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4" autoAdjust="0"/>
    <p:restoredTop sz="94660"/>
  </p:normalViewPr>
  <p:slideViewPr>
    <p:cSldViewPr snapToGrid="0">
      <p:cViewPr>
        <p:scale>
          <a:sx n="140" d="100"/>
          <a:sy n="140" d="100"/>
        </p:scale>
        <p:origin x="1764" y="-2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446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474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602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343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139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935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673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961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853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2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817AB-B64F-4483-928F-8CC3570B70F1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EA7E3-0195-48C5-B82C-5CA119CA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105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98D1E82-94E7-524C-B5DB-3D3BB4740409}"/>
              </a:ext>
            </a:extLst>
          </p:cNvPr>
          <p:cNvSpPr txBox="1"/>
          <p:nvPr/>
        </p:nvSpPr>
        <p:spPr>
          <a:xfrm>
            <a:off x="212036" y="6962362"/>
            <a:ext cx="625636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S1 Fig. Serum cytokine responses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ytokines were assessed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in serum by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a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22-plex rat-specific 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Luminex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kit.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CTL represent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ock-infected rats.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For statistical analysis, 2-way ANOVA with multiple comparisons was performed (see Methods section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).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The #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in the bottom right corner indicates significance by 2-way ANOVA (N.S., not significant; #, P &lt; 0.05; ##, P &lt; 0.01; ###, P &lt; 0.001; ####, P &lt; 0.0001); asterisks above symbols indicate significance of individual time points compared to uninfected (*, P &lt; 0.05; **, P &lt; 0.01; ***, P &lt; 0.001; ****, P &lt; 0.0001). Asterisk above a bar indicates significance over the encompassed data points.</a:t>
            </a:r>
          </a:p>
          <a:p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855" y="320675"/>
            <a:ext cx="6858000" cy="6010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0396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122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enter for Vaccine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tman, Amy Lynn</dc:creator>
  <cp:lastModifiedBy>Hartman, Amy Lynn</cp:lastModifiedBy>
  <cp:revision>14</cp:revision>
  <cp:lastPrinted>2019-04-18T16:17:53Z</cp:lastPrinted>
  <dcterms:created xsi:type="dcterms:W3CDTF">2019-04-16T18:48:22Z</dcterms:created>
  <dcterms:modified xsi:type="dcterms:W3CDTF">2019-04-23T13:18:49Z</dcterms:modified>
</cp:coreProperties>
</file>